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2" r:id="rId3"/>
    <p:sldId id="271" r:id="rId4"/>
    <p:sldId id="269" r:id="rId5"/>
    <p:sldId id="27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0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76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40243B-C9D9-4E37-8A9B-975BA0714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A714692-240B-41C5-8C90-F164BAD8D7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9EF380-C5C3-4129-8EEE-D4E623AC8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7BB1000-A6C0-4C62-B2EA-1FD1D9783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E3F364-DC77-44FD-8491-23302B6B0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0617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F54C79-CE91-4E61-8E4D-D33854ED0B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6DFD16E-473E-4D8B-A930-A65036E800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7A1B09-20F6-48E8-B7A4-59C60E4C61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3D38E91-8B3C-42C4-81BA-2A528F65A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78CFB91-036B-455E-ADB7-9BCA99A45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9755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AF64375-249E-4A22-B075-930765B156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0D4BDBB-E397-401F-81CC-ACD122A422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B2B769-92F2-4A7C-A9AE-92647EE79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B978F82-22F3-4700-905C-B8BF30FA6A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8A028F0-7A7E-4402-8B38-E013B57CE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0945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D32A81-633D-4770-80E3-A7A9DDD1B4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C7CBB39-00E4-41AC-A959-E946ABF615C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656EC8-08E9-44FD-BCFA-0F41EB3195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44FEB1-A99B-445C-9FDD-26525761A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D1EB348-1246-4E52-9BF8-63186A603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570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2F3AAD-9A47-4021-9DD9-6228DA476D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704A4F6-104B-419C-BB48-F4C993E0F8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BA6A41-D01F-42A5-A0CB-C3858E782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1B6E1E1-1D4E-46ED-ABE7-9809687FE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CF9A44-A457-4832-BF3D-DD4F4B1600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9452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DFBED2-9502-4A6E-9B63-6FD5D4C813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38064D-07F7-4F1C-B27F-2EBBE2CB19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ADBD82-67F9-480E-9432-3763B19B37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D2A9A7C-C81A-4CA4-975E-A60478CCD3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D52C19B-593E-4BA2-BB98-C13F532859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69C6D4-056C-4CB7-A498-2298945DB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751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32F730-5371-47F1-B409-A5EA0A7D76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17530FC-E9BF-4073-8401-C6C23EF02B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0936AD0-1C01-439A-B5AA-D0CF7C96C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027F032-1417-4983-B5B7-DBC3D6FFD9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1EC7F1C-5D7C-4352-B083-8B2D581E6DF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578B67B-AF5E-4672-9A72-D4789F00B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85725B8-1C48-419D-B7F3-8927ABCAA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82102D0-C63F-4A18-A7D1-BA31B9A89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6365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659908-829A-456D-96A3-24686DDA2F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A86B67D-AF34-4215-A1F8-513DA4717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00DA581-5376-4789-9A85-EE2D12191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3AB3051E-C5C3-47E4-A22A-EB298DC97F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97172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2BEF6F9-93DC-4307-9D39-F0E43AF5A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D19725D-91E4-4FEE-8026-BE495B9B6D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6FA0E68-5D0B-4062-AD51-69B71FEFA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552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3426F6B-2031-490C-A5A1-65A46833B0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25BFA83-4F0E-48B7-A0D0-99003B0259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35C5ED-0C58-4A9C-AFAC-BDAC71E895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E7E3A4-5DDB-4572-BEE1-ADA34AA13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EC9AD49-1057-4906-AD26-A3BF50F48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353386-48BC-441A-AF4F-EA28190F8A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3293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4EF8F9-F59E-4069-8FE5-2FE2FE57F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2A3F154-31B2-4BEE-94E9-6B8D74BAAF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C1A9FAF-7263-4725-A1FD-9E39D8EFA0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C23A9AF-2003-4B75-81D2-AA19AE85A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697D45-5293-4E16-AD0B-CFCBA799F8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DA7F62-83E4-4285-8BB4-718119A4D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479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46B0D66-E7A9-404C-802C-1EBC6B2DE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3C41F8-CAC3-4F72-B536-F69A4C9D7F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62B3CA-E3A6-4CCE-9F05-A2E288C4AB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8AFC6-13FD-4E22-A777-ADA0D84621F1}" type="datetimeFigureOut">
              <a:rPr lang="zh-CN" altLang="en-US" smtClean="0"/>
              <a:t>2021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5B4F2E-532A-4F73-B9F5-358176767D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FCDDD7-43F4-42EC-A33C-A6605D4619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54724B-5179-4858-A70D-A68C8BF6CF2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6141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5981E30-44F0-4A4A-8441-36555543AD6C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1B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D3BFD39-E97C-40F1-A15C-EE85CC281B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54475" y="600075"/>
            <a:ext cx="3835400" cy="3143250"/>
          </a:xfrm>
          <a:prstGeom prst="rect">
            <a:avLst/>
          </a:prstGeom>
        </p:spPr>
      </p:pic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A415586A-0218-4402-8F99-7663D17FA6C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7823582"/>
              </p:ext>
            </p:extLst>
          </p:nvPr>
        </p:nvGraphicFramePr>
        <p:xfrm>
          <a:off x="838200" y="3874505"/>
          <a:ext cx="10515600" cy="1088020"/>
        </p:xfrm>
        <a:graphic>
          <a:graphicData uri="http://schemas.openxmlformats.org/drawingml/2006/table">
            <a:tbl>
              <a:tblPr/>
              <a:tblGrid>
                <a:gridCol w="876300">
                  <a:extLst>
                    <a:ext uri="{9D8B030D-6E8A-4147-A177-3AD203B41FA5}">
                      <a16:colId xmlns:a16="http://schemas.microsoft.com/office/drawing/2014/main" val="814796375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54301331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262634728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04094121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840118870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245441713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57288871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732405359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339028679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759355440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62641133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399467120"/>
                    </a:ext>
                  </a:extLst>
                </a:gridCol>
              </a:tblGrid>
              <a:tr h="544010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 dirty="0"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Mtx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Cis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1817885"/>
                  </a:ext>
                </a:extLst>
              </a:tr>
              <a:tr h="54401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.637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0.437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4.626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.427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6.367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2.462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9.151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2.262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9469595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00C48B67-7CCD-48E1-8A5B-BA1DC944DE87}"/>
              </a:ext>
            </a:extLst>
          </p:cNvPr>
          <p:cNvSpPr txBox="1"/>
          <p:nvPr/>
        </p:nvSpPr>
        <p:spPr>
          <a:xfrm>
            <a:off x="2242086" y="5340428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B32DEB4-4DFD-4B5F-A09E-9B9177E1BA6A}"/>
              </a:ext>
            </a:extLst>
          </p:cNvPr>
          <p:cNvSpPr txBox="1"/>
          <p:nvPr/>
        </p:nvSpPr>
        <p:spPr>
          <a:xfrm>
            <a:off x="1384836" y="533352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860F04A-2EAF-4E5C-BBBF-D53209FF3C0B}"/>
              </a:ext>
            </a:extLst>
          </p:cNvPr>
          <p:cNvSpPr txBox="1"/>
          <p:nvPr/>
        </p:nvSpPr>
        <p:spPr>
          <a:xfrm>
            <a:off x="3242211" y="533352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43C62F6-2648-4E0D-B749-5E7D0FEF815D}"/>
              </a:ext>
            </a:extLst>
          </p:cNvPr>
          <p:cNvSpPr txBox="1"/>
          <p:nvPr/>
        </p:nvSpPr>
        <p:spPr>
          <a:xfrm>
            <a:off x="4880511" y="533411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509D33E-32E5-4547-A5F2-D55A71954AF2}"/>
              </a:ext>
            </a:extLst>
          </p:cNvPr>
          <p:cNvSpPr txBox="1"/>
          <p:nvPr/>
        </p:nvSpPr>
        <p:spPr>
          <a:xfrm>
            <a:off x="3889911" y="532721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5E17997-DB8E-4E37-A249-1D63E15B3575}"/>
              </a:ext>
            </a:extLst>
          </p:cNvPr>
          <p:cNvSpPr txBox="1"/>
          <p:nvPr/>
        </p:nvSpPr>
        <p:spPr>
          <a:xfrm>
            <a:off x="5842536" y="532721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96CA488-06B2-470D-A127-C0E376E11E45}"/>
              </a:ext>
            </a:extLst>
          </p:cNvPr>
          <p:cNvSpPr txBox="1"/>
          <p:nvPr/>
        </p:nvSpPr>
        <p:spPr>
          <a:xfrm>
            <a:off x="7475022" y="534102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F22FF6C-A88A-41BF-BD90-EB08F156DA9A}"/>
              </a:ext>
            </a:extLst>
          </p:cNvPr>
          <p:cNvSpPr txBox="1"/>
          <p:nvPr/>
        </p:nvSpPr>
        <p:spPr>
          <a:xfrm>
            <a:off x="6493947" y="533411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44CF1B4F-B151-4D2B-B23B-FF99600A7AFC}"/>
              </a:ext>
            </a:extLst>
          </p:cNvPr>
          <p:cNvSpPr txBox="1"/>
          <p:nvPr/>
        </p:nvSpPr>
        <p:spPr>
          <a:xfrm>
            <a:off x="8532297" y="533411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058D398-8697-4F05-9B26-4AD28BF77FB7}"/>
              </a:ext>
            </a:extLst>
          </p:cNvPr>
          <p:cNvSpPr txBox="1"/>
          <p:nvPr/>
        </p:nvSpPr>
        <p:spPr>
          <a:xfrm>
            <a:off x="10233561" y="532721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05FA78D-3CC0-453F-83B2-EFC2BA97D62D}"/>
              </a:ext>
            </a:extLst>
          </p:cNvPr>
          <p:cNvSpPr txBox="1"/>
          <p:nvPr/>
        </p:nvSpPr>
        <p:spPr>
          <a:xfrm>
            <a:off x="9147711" y="532030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32EFF9E-5491-4A0A-9ADC-2FD7FE136913}"/>
              </a:ext>
            </a:extLst>
          </p:cNvPr>
          <p:cNvSpPr txBox="1"/>
          <p:nvPr/>
        </p:nvSpPr>
        <p:spPr>
          <a:xfrm>
            <a:off x="11109861" y="532030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768494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5981E30-44F0-4A4A-8441-36555543AD6C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1B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02A9EE4-8F51-4DEC-A5DD-A89EBAEC77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30650" y="536575"/>
            <a:ext cx="3835400" cy="3327400"/>
          </a:xfrm>
          <a:prstGeom prst="rect">
            <a:avLst/>
          </a:prstGeom>
        </p:spPr>
      </p:pic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69A29BE7-3B9E-4F0B-AE5B-35C44C3806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9390979"/>
              </p:ext>
            </p:extLst>
          </p:nvPr>
        </p:nvGraphicFramePr>
        <p:xfrm>
          <a:off x="838200" y="3863975"/>
          <a:ext cx="10515600" cy="1011820"/>
        </p:xfrm>
        <a:graphic>
          <a:graphicData uri="http://schemas.openxmlformats.org/drawingml/2006/table">
            <a:tbl>
              <a:tblPr/>
              <a:tblGrid>
                <a:gridCol w="876300">
                  <a:extLst>
                    <a:ext uri="{9D8B030D-6E8A-4147-A177-3AD203B41FA5}">
                      <a16:colId xmlns:a16="http://schemas.microsoft.com/office/drawing/2014/main" val="2963723525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229058723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77853883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834736645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864203023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611566310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887165435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72954863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3063422318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876063264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1122840598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491546508"/>
                    </a:ext>
                  </a:extLst>
                </a:gridCol>
              </a:tblGrid>
              <a:tr h="505910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Mtx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Cis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49445598"/>
                  </a:ext>
                </a:extLst>
              </a:tr>
              <a:tr h="50591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.99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.825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8.559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2.556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0.088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2.488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27.876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6860515"/>
                  </a:ext>
                </a:extLst>
              </a:tr>
            </a:tbl>
          </a:graphicData>
        </a:graphic>
      </p:graphicFrame>
      <p:sp>
        <p:nvSpPr>
          <p:cNvPr id="6" name="文本框 5">
            <a:extLst>
              <a:ext uri="{FF2B5EF4-FFF2-40B4-BE49-F238E27FC236}">
                <a16:creationId xmlns:a16="http://schemas.microsoft.com/office/drawing/2014/main" id="{B204595B-1D8A-41E6-AFBE-27DB837C0452}"/>
              </a:ext>
            </a:extLst>
          </p:cNvPr>
          <p:cNvSpPr txBox="1"/>
          <p:nvPr/>
        </p:nvSpPr>
        <p:spPr>
          <a:xfrm>
            <a:off x="2251611" y="5340428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35636E22-88B2-4DA3-A13F-B8448D27ED47}"/>
              </a:ext>
            </a:extLst>
          </p:cNvPr>
          <p:cNvSpPr txBox="1"/>
          <p:nvPr/>
        </p:nvSpPr>
        <p:spPr>
          <a:xfrm>
            <a:off x="1394361" y="533352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B94DD69-C621-423B-B345-3462FF509961}"/>
              </a:ext>
            </a:extLst>
          </p:cNvPr>
          <p:cNvSpPr txBox="1"/>
          <p:nvPr/>
        </p:nvSpPr>
        <p:spPr>
          <a:xfrm>
            <a:off x="3251736" y="533352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8C9EBB1-213F-48C9-9220-602C84068641}"/>
              </a:ext>
            </a:extLst>
          </p:cNvPr>
          <p:cNvSpPr txBox="1"/>
          <p:nvPr/>
        </p:nvSpPr>
        <p:spPr>
          <a:xfrm>
            <a:off x="4890036" y="533411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247A79B-DEF5-42B9-ADC5-5F93124085FC}"/>
              </a:ext>
            </a:extLst>
          </p:cNvPr>
          <p:cNvSpPr txBox="1"/>
          <p:nvPr/>
        </p:nvSpPr>
        <p:spPr>
          <a:xfrm>
            <a:off x="3899436" y="532721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61361DC-24E2-435F-81B9-D147B9D61535}"/>
              </a:ext>
            </a:extLst>
          </p:cNvPr>
          <p:cNvSpPr txBox="1"/>
          <p:nvPr/>
        </p:nvSpPr>
        <p:spPr>
          <a:xfrm>
            <a:off x="5852061" y="532721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4D51611-3CEB-455F-BD14-276B79B8C6F8}"/>
              </a:ext>
            </a:extLst>
          </p:cNvPr>
          <p:cNvSpPr txBox="1"/>
          <p:nvPr/>
        </p:nvSpPr>
        <p:spPr>
          <a:xfrm>
            <a:off x="7484547" y="534102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5FB5E1C-2F9A-4390-9100-FCC27698D953}"/>
              </a:ext>
            </a:extLst>
          </p:cNvPr>
          <p:cNvSpPr txBox="1"/>
          <p:nvPr/>
        </p:nvSpPr>
        <p:spPr>
          <a:xfrm>
            <a:off x="6503472" y="533411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E87D6E4-01E3-422A-AAE6-79099B8AD8C7}"/>
              </a:ext>
            </a:extLst>
          </p:cNvPr>
          <p:cNvSpPr txBox="1"/>
          <p:nvPr/>
        </p:nvSpPr>
        <p:spPr>
          <a:xfrm>
            <a:off x="8541822" y="533411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7D5779E-E2EA-45B1-8FCB-447FFAD0EAD2}"/>
              </a:ext>
            </a:extLst>
          </p:cNvPr>
          <p:cNvSpPr txBox="1"/>
          <p:nvPr/>
        </p:nvSpPr>
        <p:spPr>
          <a:xfrm>
            <a:off x="10243086" y="532721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A4F9379-90BD-410E-BB38-427347049E69}"/>
              </a:ext>
            </a:extLst>
          </p:cNvPr>
          <p:cNvSpPr txBox="1"/>
          <p:nvPr/>
        </p:nvSpPr>
        <p:spPr>
          <a:xfrm>
            <a:off x="9157236" y="532030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08818D2-960E-46A3-84A9-3703F3354261}"/>
              </a:ext>
            </a:extLst>
          </p:cNvPr>
          <p:cNvSpPr txBox="1"/>
          <p:nvPr/>
        </p:nvSpPr>
        <p:spPr>
          <a:xfrm>
            <a:off x="11119386" y="532030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992841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5981E30-44F0-4A4A-8441-36555543AD6C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1B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4CBE7A8C-ABDF-4B35-B8FD-8D4580075D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63975" y="581025"/>
            <a:ext cx="3835400" cy="3143250"/>
          </a:xfrm>
          <a:prstGeom prst="rect">
            <a:avLst/>
          </a:prstGeom>
        </p:spPr>
      </p:pic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405F579F-FF4B-4D09-8509-76F58BFFA1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581338"/>
              </p:ext>
            </p:extLst>
          </p:nvPr>
        </p:nvGraphicFramePr>
        <p:xfrm>
          <a:off x="838200" y="3874505"/>
          <a:ext cx="10515600" cy="1183270"/>
        </p:xfrm>
        <a:graphic>
          <a:graphicData uri="http://schemas.openxmlformats.org/drawingml/2006/table">
            <a:tbl>
              <a:tblPr/>
              <a:tblGrid>
                <a:gridCol w="876300">
                  <a:extLst>
                    <a:ext uri="{9D8B030D-6E8A-4147-A177-3AD203B41FA5}">
                      <a16:colId xmlns:a16="http://schemas.microsoft.com/office/drawing/2014/main" val="257149914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85112004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3844000900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095814654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10687838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305429623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3771977184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853676422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711212510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73095213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2783481184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508274806"/>
                    </a:ext>
                  </a:extLst>
                </a:gridCol>
              </a:tblGrid>
              <a:tr h="591635"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-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Mtx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effectLst/>
                          <a:latin typeface="Arial" panose="020B0604020202020204" pitchFamily="34" charset="0"/>
                        </a:rPr>
                        <a:t>Cis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6394600"/>
                  </a:ext>
                </a:extLst>
              </a:tr>
              <a:tr h="591635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.08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0.519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3.777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.722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4.38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.402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16.116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>
                          <a:effectLst/>
                          <a:latin typeface="Arial" panose="020B0604020202020204" pitchFamily="34" charset="0"/>
                        </a:rPr>
                        <a:t>2.546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zh-CN" sz="800" b="0" i="0" u="none" strike="noStrike" dirty="0"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4868" marR="4868" marT="486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0707454"/>
                  </a:ext>
                </a:extLst>
              </a:tr>
            </a:tbl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09760A0E-6B6F-4208-94A4-48F3179A515A}"/>
              </a:ext>
            </a:extLst>
          </p:cNvPr>
          <p:cNvSpPr txBox="1"/>
          <p:nvPr/>
        </p:nvSpPr>
        <p:spPr>
          <a:xfrm>
            <a:off x="2251611" y="5340428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249334D-7E26-44FF-8153-AE976E13D023}"/>
              </a:ext>
            </a:extLst>
          </p:cNvPr>
          <p:cNvSpPr txBox="1"/>
          <p:nvPr/>
        </p:nvSpPr>
        <p:spPr>
          <a:xfrm>
            <a:off x="1394361" y="533352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E3301A91-6F88-4799-8D86-C5300F49F0B8}"/>
              </a:ext>
            </a:extLst>
          </p:cNvPr>
          <p:cNvSpPr txBox="1"/>
          <p:nvPr/>
        </p:nvSpPr>
        <p:spPr>
          <a:xfrm>
            <a:off x="3251736" y="533352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C64F5E01-1426-4211-8E19-6801791A6989}"/>
              </a:ext>
            </a:extLst>
          </p:cNvPr>
          <p:cNvSpPr txBox="1"/>
          <p:nvPr/>
        </p:nvSpPr>
        <p:spPr>
          <a:xfrm>
            <a:off x="4890036" y="533411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C253765F-3A4B-4BD1-9C4C-A3939756872F}"/>
              </a:ext>
            </a:extLst>
          </p:cNvPr>
          <p:cNvSpPr txBox="1"/>
          <p:nvPr/>
        </p:nvSpPr>
        <p:spPr>
          <a:xfrm>
            <a:off x="3899436" y="532721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9FE2304-B004-446E-B8DD-44BCDFCC723E}"/>
              </a:ext>
            </a:extLst>
          </p:cNvPr>
          <p:cNvSpPr txBox="1"/>
          <p:nvPr/>
        </p:nvSpPr>
        <p:spPr>
          <a:xfrm>
            <a:off x="5852061" y="532721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7EB9898-127A-4BD2-A21A-9919B2B6A960}"/>
              </a:ext>
            </a:extLst>
          </p:cNvPr>
          <p:cNvSpPr txBox="1"/>
          <p:nvPr/>
        </p:nvSpPr>
        <p:spPr>
          <a:xfrm>
            <a:off x="7484547" y="534102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28BF0825-01AB-4AB9-BC92-206B27CE890A}"/>
              </a:ext>
            </a:extLst>
          </p:cNvPr>
          <p:cNvSpPr txBox="1"/>
          <p:nvPr/>
        </p:nvSpPr>
        <p:spPr>
          <a:xfrm>
            <a:off x="6503472" y="533411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9A73F89-6209-4006-B6B7-DCEA872A6CB1}"/>
              </a:ext>
            </a:extLst>
          </p:cNvPr>
          <p:cNvSpPr txBox="1"/>
          <p:nvPr/>
        </p:nvSpPr>
        <p:spPr>
          <a:xfrm>
            <a:off x="8541822" y="533411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A3751DC-7FFC-4FFD-B477-55A0FE027627}"/>
              </a:ext>
            </a:extLst>
          </p:cNvPr>
          <p:cNvSpPr txBox="1"/>
          <p:nvPr/>
        </p:nvSpPr>
        <p:spPr>
          <a:xfrm>
            <a:off x="10243086" y="5327212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D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9FDEF2F-D654-42B2-8634-3230963D2DCA}"/>
              </a:ext>
            </a:extLst>
          </p:cNvPr>
          <p:cNvSpPr txBox="1"/>
          <p:nvPr/>
        </p:nvSpPr>
        <p:spPr>
          <a:xfrm>
            <a:off x="9157236" y="532030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Mean</a:t>
            </a:r>
            <a:endParaRPr lang="zh-CN" altLang="en-US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FAEDAD9-571D-45D0-8AEE-BDDB115CA6B1}"/>
              </a:ext>
            </a:extLst>
          </p:cNvPr>
          <p:cNvSpPr txBox="1"/>
          <p:nvPr/>
        </p:nvSpPr>
        <p:spPr>
          <a:xfrm>
            <a:off x="11119386" y="5320307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256469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5981E30-44F0-4A4A-8441-36555543AD6C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B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B53BC4DB-4368-4737-BEE0-814202D2A6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1425" y="571500"/>
            <a:ext cx="3886200" cy="314325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B236DAFA-1547-4964-A92E-B00DFD20224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656" t="14861" r="33282" b="72084"/>
          <a:stretch/>
        </p:blipFill>
        <p:spPr>
          <a:xfrm>
            <a:off x="3343275" y="4248149"/>
            <a:ext cx="4762500" cy="895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83874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D5981E30-44F0-4A4A-8441-36555543AD6C}"/>
              </a:ext>
            </a:extLst>
          </p:cNvPr>
          <p:cNvSpPr txBox="1"/>
          <p:nvPr/>
        </p:nvSpPr>
        <p:spPr>
          <a:xfrm>
            <a:off x="70386" y="56673"/>
            <a:ext cx="10953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. 2B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DB0DAE9-4B87-4C7C-9F11-CD93699B6D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5250" y="426005"/>
            <a:ext cx="3886200" cy="33274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ECDD3E8-8D41-47AB-8719-AC81108CBF2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656" t="15278" r="33282" b="71805"/>
          <a:stretch/>
        </p:blipFill>
        <p:spPr>
          <a:xfrm>
            <a:off x="3028950" y="4038600"/>
            <a:ext cx="4762500" cy="885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42125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0</TotalTime>
  <Words>99</Words>
  <Application>Microsoft Office PowerPoint</Application>
  <PresentationFormat>宽屏</PresentationFormat>
  <Paragraphs>89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汤 臻</dc:creator>
  <cp:lastModifiedBy>汤 臻</cp:lastModifiedBy>
  <cp:revision>26</cp:revision>
  <dcterms:created xsi:type="dcterms:W3CDTF">2021-06-15T01:43:45Z</dcterms:created>
  <dcterms:modified xsi:type="dcterms:W3CDTF">2021-06-15T08:35:17Z</dcterms:modified>
</cp:coreProperties>
</file>